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0" d="100"/>
          <a:sy n="120" d="100"/>
        </p:scale>
        <p:origin x="-1746" y="-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1488E-8C78-4A2F-92F7-D25119A82929}" type="datetimeFigureOut">
              <a:rPr lang="en-US" smtClean="0"/>
              <a:t>8/1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A38D3-C888-4BC1-85BB-011BB621DF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273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1488E-8C78-4A2F-92F7-D25119A82929}" type="datetimeFigureOut">
              <a:rPr lang="en-US" smtClean="0"/>
              <a:t>8/1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A38D3-C888-4BC1-85BB-011BB621DF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9279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1488E-8C78-4A2F-92F7-D25119A82929}" type="datetimeFigureOut">
              <a:rPr lang="en-US" smtClean="0"/>
              <a:t>8/1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A38D3-C888-4BC1-85BB-011BB621DF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7429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1488E-8C78-4A2F-92F7-D25119A82929}" type="datetimeFigureOut">
              <a:rPr lang="en-US" smtClean="0"/>
              <a:t>8/1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A38D3-C888-4BC1-85BB-011BB621DF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62262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1488E-8C78-4A2F-92F7-D25119A82929}" type="datetimeFigureOut">
              <a:rPr lang="en-US" smtClean="0"/>
              <a:t>8/1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A38D3-C888-4BC1-85BB-011BB621DF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7639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1488E-8C78-4A2F-92F7-D25119A82929}" type="datetimeFigureOut">
              <a:rPr lang="en-US" smtClean="0"/>
              <a:t>8/1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A38D3-C888-4BC1-85BB-011BB621DF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88299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1488E-8C78-4A2F-92F7-D25119A82929}" type="datetimeFigureOut">
              <a:rPr lang="en-US" smtClean="0"/>
              <a:t>8/12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A38D3-C888-4BC1-85BB-011BB621DF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04159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1488E-8C78-4A2F-92F7-D25119A82929}" type="datetimeFigureOut">
              <a:rPr lang="en-US" smtClean="0"/>
              <a:t>8/12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A38D3-C888-4BC1-85BB-011BB621DF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64550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1488E-8C78-4A2F-92F7-D25119A82929}" type="datetimeFigureOut">
              <a:rPr lang="en-US" smtClean="0"/>
              <a:t>8/12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A38D3-C888-4BC1-85BB-011BB621DF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18678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1488E-8C78-4A2F-92F7-D25119A82929}" type="datetimeFigureOut">
              <a:rPr lang="en-US" smtClean="0"/>
              <a:t>8/1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A38D3-C888-4BC1-85BB-011BB621DF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85235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C1488E-8C78-4A2F-92F7-D25119A82929}" type="datetimeFigureOut">
              <a:rPr lang="en-US" smtClean="0"/>
              <a:t>8/1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A38D3-C888-4BC1-85BB-011BB621DF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45074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C1488E-8C78-4A2F-92F7-D25119A82929}" type="datetimeFigureOut">
              <a:rPr lang="en-US" smtClean="0"/>
              <a:t>8/1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FA38D3-C888-4BC1-85BB-011BB621DF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1037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60648" y="344488"/>
            <a:ext cx="766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Figure S1</a:t>
            </a:r>
            <a:endParaRPr lang="en-US" sz="12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404664" y="704528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A</a:t>
            </a:r>
            <a:endParaRPr lang="en-US" sz="12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366222" y="3584848"/>
            <a:ext cx="2712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B</a:t>
            </a:r>
            <a:endParaRPr lang="en-US" sz="12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327780" y="6764233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C</a:t>
            </a:r>
            <a:endParaRPr lang="en-US" sz="1200" b="1" dirty="0"/>
          </a:p>
        </p:txBody>
      </p:sp>
      <p:grpSp>
        <p:nvGrpSpPr>
          <p:cNvPr id="8" name="Group 7"/>
          <p:cNvGrpSpPr/>
          <p:nvPr/>
        </p:nvGrpSpPr>
        <p:grpSpPr>
          <a:xfrm>
            <a:off x="520721" y="964606"/>
            <a:ext cx="5770279" cy="2620242"/>
            <a:chOff x="520721" y="964606"/>
            <a:chExt cx="5770279" cy="2620242"/>
          </a:xfrm>
        </p:grpSpPr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67000" y="964606"/>
              <a:ext cx="5724000" cy="26202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 rot="16200000">
              <a:off x="-200791" y="2074112"/>
              <a:ext cx="1673856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sz="900" b="1" dirty="0" smtClean="0"/>
                <a:t>White blood cell count (x10</a:t>
              </a:r>
              <a:r>
                <a:rPr lang="en-GB" sz="900" b="1" baseline="30000" dirty="0" smtClean="0"/>
                <a:t>9</a:t>
              </a:r>
              <a:r>
                <a:rPr lang="en-GB" sz="900" b="1" dirty="0" smtClean="0"/>
                <a:t>/L)</a:t>
              </a:r>
              <a:endParaRPr lang="en-US" sz="900" b="1" dirty="0"/>
            </a:p>
          </p:txBody>
        </p:sp>
      </p:grp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7000" y="3872880"/>
            <a:ext cx="5724000" cy="26916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TextBox 12"/>
          <p:cNvSpPr txBox="1"/>
          <p:nvPr/>
        </p:nvSpPr>
        <p:spPr>
          <a:xfrm rot="16200000">
            <a:off x="-80458" y="5080776"/>
            <a:ext cx="1383712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900" b="1" dirty="0" smtClean="0"/>
              <a:t>Change in spleen size (%)</a:t>
            </a:r>
            <a:endParaRPr lang="en-US" sz="900" b="1" dirty="0"/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7000" y="6764233"/>
            <a:ext cx="5724000" cy="26100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" name="TextBox 17"/>
          <p:cNvSpPr txBox="1"/>
          <p:nvPr/>
        </p:nvSpPr>
        <p:spPr>
          <a:xfrm rot="16200000">
            <a:off x="77619" y="7971222"/>
            <a:ext cx="1077539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900" b="1" dirty="0" smtClean="0"/>
              <a:t>Haemoglobin (g/L)</a:t>
            </a:r>
            <a:endParaRPr lang="en-US" sz="9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2023860" y="1056748"/>
            <a:ext cx="511926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BMF status:</a:t>
            </a:r>
            <a:endParaRPr lang="en-US" sz="7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2120603" y="3997084"/>
            <a:ext cx="511926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BMF status:</a:t>
            </a:r>
            <a:endParaRPr lang="en-US" sz="7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2109003" y="6873812"/>
            <a:ext cx="511926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BMF status:</a:t>
            </a:r>
            <a:endParaRPr lang="en-US" sz="7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2902648" y="1056617"/>
            <a:ext cx="582458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Improvement</a:t>
            </a:r>
            <a:endParaRPr lang="en-US" sz="7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3781436" y="1056486"/>
            <a:ext cx="534368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Stabilization</a:t>
            </a:r>
            <a:endParaRPr lang="en-US" sz="7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4660224" y="1056355"/>
            <a:ext cx="476660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Worsening</a:t>
            </a:r>
            <a:endParaRPr lang="en-US" sz="700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2924944" y="3989133"/>
            <a:ext cx="582458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Improvement</a:t>
            </a:r>
            <a:endParaRPr lang="en-US" sz="700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3803732" y="3989002"/>
            <a:ext cx="534368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Stabilization</a:t>
            </a:r>
            <a:endParaRPr lang="en-US" sz="7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4682520" y="3988871"/>
            <a:ext cx="476660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Worsening</a:t>
            </a:r>
            <a:endParaRPr lang="en-US" sz="700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2916993" y="6865992"/>
            <a:ext cx="582458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Improvement</a:t>
            </a:r>
            <a:endParaRPr lang="en-US" sz="700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3795781" y="6865861"/>
            <a:ext cx="534368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Stabilization</a:t>
            </a:r>
            <a:endParaRPr lang="en-US" sz="700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4674569" y="6865730"/>
            <a:ext cx="476660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Worsening</a:t>
            </a:r>
            <a:endParaRPr lang="en-US" sz="700" b="1" dirty="0"/>
          </a:p>
        </p:txBody>
      </p:sp>
      <p:sp>
        <p:nvSpPr>
          <p:cNvPr id="31" name="TextBox 30"/>
          <p:cNvSpPr txBox="1"/>
          <p:nvPr/>
        </p:nvSpPr>
        <p:spPr>
          <a:xfrm>
            <a:off x="1077038" y="3436922"/>
            <a:ext cx="333993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Cycle 6</a:t>
            </a:r>
            <a:endParaRPr lang="en-US" sz="700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1718904" y="3436922"/>
            <a:ext cx="378877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Cycle 12</a:t>
            </a:r>
            <a:endParaRPr lang="en-US" sz="700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2376672" y="3436922"/>
            <a:ext cx="378877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Cycle 18</a:t>
            </a:r>
            <a:endParaRPr lang="en-US" sz="700" b="1" dirty="0"/>
          </a:p>
        </p:txBody>
      </p:sp>
      <p:sp>
        <p:nvSpPr>
          <p:cNvPr id="34" name="TextBox 33"/>
          <p:cNvSpPr txBox="1"/>
          <p:nvPr/>
        </p:nvSpPr>
        <p:spPr>
          <a:xfrm>
            <a:off x="3034440" y="3436922"/>
            <a:ext cx="378877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Cycle 24</a:t>
            </a:r>
            <a:endParaRPr lang="en-US" sz="700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3708110" y="3436922"/>
            <a:ext cx="378877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Cycle 30</a:t>
            </a:r>
            <a:endParaRPr lang="en-US" sz="700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4365878" y="3436922"/>
            <a:ext cx="378877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Cycle 36</a:t>
            </a:r>
            <a:endParaRPr lang="en-US" sz="700" b="1" dirty="0"/>
          </a:p>
        </p:txBody>
      </p:sp>
      <p:sp>
        <p:nvSpPr>
          <p:cNvPr id="37" name="TextBox 36"/>
          <p:cNvSpPr txBox="1"/>
          <p:nvPr/>
        </p:nvSpPr>
        <p:spPr>
          <a:xfrm>
            <a:off x="5023646" y="3436922"/>
            <a:ext cx="378877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Cycle 42</a:t>
            </a:r>
            <a:endParaRPr lang="en-US" sz="700" b="1" dirty="0"/>
          </a:p>
        </p:txBody>
      </p:sp>
      <p:sp>
        <p:nvSpPr>
          <p:cNvPr id="38" name="TextBox 37"/>
          <p:cNvSpPr txBox="1"/>
          <p:nvPr/>
        </p:nvSpPr>
        <p:spPr>
          <a:xfrm>
            <a:off x="5677150" y="3436922"/>
            <a:ext cx="378877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Cycle 48</a:t>
            </a:r>
            <a:endParaRPr lang="en-US" sz="700" b="1" dirty="0"/>
          </a:p>
        </p:txBody>
      </p:sp>
      <p:sp>
        <p:nvSpPr>
          <p:cNvPr id="39" name="TextBox 38"/>
          <p:cNvSpPr txBox="1"/>
          <p:nvPr/>
        </p:nvSpPr>
        <p:spPr>
          <a:xfrm>
            <a:off x="1140197" y="6373348"/>
            <a:ext cx="333993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Cycle 6</a:t>
            </a:r>
            <a:endParaRPr lang="en-US" sz="700" b="1" dirty="0"/>
          </a:p>
        </p:txBody>
      </p:sp>
      <p:sp>
        <p:nvSpPr>
          <p:cNvPr id="40" name="TextBox 39"/>
          <p:cNvSpPr txBox="1"/>
          <p:nvPr/>
        </p:nvSpPr>
        <p:spPr>
          <a:xfrm>
            <a:off x="1774112" y="6373348"/>
            <a:ext cx="378877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Cycle 12</a:t>
            </a:r>
            <a:endParaRPr lang="en-US" sz="700" b="1" dirty="0"/>
          </a:p>
        </p:txBody>
      </p:sp>
      <p:sp>
        <p:nvSpPr>
          <p:cNvPr id="41" name="TextBox 40"/>
          <p:cNvSpPr txBox="1"/>
          <p:nvPr/>
        </p:nvSpPr>
        <p:spPr>
          <a:xfrm>
            <a:off x="2423929" y="6373348"/>
            <a:ext cx="378877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Cycle 18</a:t>
            </a:r>
            <a:endParaRPr lang="en-US" sz="700" b="1" dirty="0"/>
          </a:p>
        </p:txBody>
      </p:sp>
      <p:sp>
        <p:nvSpPr>
          <p:cNvPr id="42" name="TextBox 41"/>
          <p:cNvSpPr txBox="1"/>
          <p:nvPr/>
        </p:nvSpPr>
        <p:spPr>
          <a:xfrm>
            <a:off x="3081697" y="6373348"/>
            <a:ext cx="378877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Cycle 24</a:t>
            </a:r>
            <a:endParaRPr lang="en-US" sz="700" b="1" dirty="0"/>
          </a:p>
        </p:txBody>
      </p:sp>
      <p:sp>
        <p:nvSpPr>
          <p:cNvPr id="43" name="TextBox 42"/>
          <p:cNvSpPr txBox="1"/>
          <p:nvPr/>
        </p:nvSpPr>
        <p:spPr>
          <a:xfrm>
            <a:off x="3739465" y="6373348"/>
            <a:ext cx="378877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Cycle 30</a:t>
            </a:r>
            <a:endParaRPr lang="en-US" sz="700" b="1" dirty="0"/>
          </a:p>
        </p:txBody>
      </p:sp>
      <p:sp>
        <p:nvSpPr>
          <p:cNvPr id="44" name="TextBox 43"/>
          <p:cNvSpPr txBox="1"/>
          <p:nvPr/>
        </p:nvSpPr>
        <p:spPr>
          <a:xfrm>
            <a:off x="4389282" y="6373348"/>
            <a:ext cx="378877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Cycle 36</a:t>
            </a:r>
            <a:endParaRPr lang="en-US" sz="700" b="1" dirty="0"/>
          </a:p>
        </p:txBody>
      </p:sp>
      <p:sp>
        <p:nvSpPr>
          <p:cNvPr id="45" name="TextBox 44"/>
          <p:cNvSpPr txBox="1"/>
          <p:nvPr/>
        </p:nvSpPr>
        <p:spPr>
          <a:xfrm>
            <a:off x="5039099" y="6373348"/>
            <a:ext cx="378877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Cycle 42</a:t>
            </a:r>
            <a:endParaRPr lang="en-US" sz="700" b="1" dirty="0"/>
          </a:p>
        </p:txBody>
      </p:sp>
      <p:sp>
        <p:nvSpPr>
          <p:cNvPr id="46" name="TextBox 45"/>
          <p:cNvSpPr txBox="1"/>
          <p:nvPr/>
        </p:nvSpPr>
        <p:spPr>
          <a:xfrm>
            <a:off x="5692603" y="6373348"/>
            <a:ext cx="378877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Cycle 48</a:t>
            </a:r>
            <a:endParaRPr lang="en-US" sz="700" b="1" dirty="0"/>
          </a:p>
        </p:txBody>
      </p:sp>
      <p:sp>
        <p:nvSpPr>
          <p:cNvPr id="47" name="TextBox 46"/>
          <p:cNvSpPr txBox="1"/>
          <p:nvPr/>
        </p:nvSpPr>
        <p:spPr>
          <a:xfrm>
            <a:off x="1121809" y="9257578"/>
            <a:ext cx="333993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Cycle 6</a:t>
            </a:r>
            <a:endParaRPr lang="en-US" sz="700" b="1" dirty="0"/>
          </a:p>
        </p:txBody>
      </p:sp>
      <p:sp>
        <p:nvSpPr>
          <p:cNvPr id="48" name="TextBox 47"/>
          <p:cNvSpPr txBox="1"/>
          <p:nvPr/>
        </p:nvSpPr>
        <p:spPr>
          <a:xfrm>
            <a:off x="1755724" y="9257578"/>
            <a:ext cx="378877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Cycle 12</a:t>
            </a:r>
            <a:endParaRPr lang="en-US" sz="700" b="1" dirty="0"/>
          </a:p>
        </p:txBody>
      </p:sp>
      <p:sp>
        <p:nvSpPr>
          <p:cNvPr id="49" name="TextBox 48"/>
          <p:cNvSpPr txBox="1"/>
          <p:nvPr/>
        </p:nvSpPr>
        <p:spPr>
          <a:xfrm>
            <a:off x="2405541" y="9257578"/>
            <a:ext cx="378877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Cycle 18</a:t>
            </a:r>
            <a:endParaRPr lang="en-US" sz="700" b="1" dirty="0"/>
          </a:p>
        </p:txBody>
      </p:sp>
      <p:sp>
        <p:nvSpPr>
          <p:cNvPr id="50" name="TextBox 49"/>
          <p:cNvSpPr txBox="1"/>
          <p:nvPr/>
        </p:nvSpPr>
        <p:spPr>
          <a:xfrm>
            <a:off x="3063309" y="9257578"/>
            <a:ext cx="378877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Cycle 24</a:t>
            </a:r>
            <a:endParaRPr lang="en-US" sz="700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3721077" y="9257578"/>
            <a:ext cx="378877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Cycle 30</a:t>
            </a:r>
            <a:endParaRPr lang="en-US" sz="700" b="1" dirty="0"/>
          </a:p>
        </p:txBody>
      </p:sp>
      <p:sp>
        <p:nvSpPr>
          <p:cNvPr id="52" name="TextBox 51"/>
          <p:cNvSpPr txBox="1"/>
          <p:nvPr/>
        </p:nvSpPr>
        <p:spPr>
          <a:xfrm>
            <a:off x="4370894" y="9257578"/>
            <a:ext cx="378877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Cycle 36</a:t>
            </a:r>
            <a:endParaRPr lang="en-US" sz="700" b="1" dirty="0"/>
          </a:p>
        </p:txBody>
      </p:sp>
      <p:sp>
        <p:nvSpPr>
          <p:cNvPr id="53" name="TextBox 52"/>
          <p:cNvSpPr txBox="1"/>
          <p:nvPr/>
        </p:nvSpPr>
        <p:spPr>
          <a:xfrm>
            <a:off x="5020711" y="9257578"/>
            <a:ext cx="378877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Cycle 42</a:t>
            </a:r>
            <a:endParaRPr lang="en-US" sz="700" b="1" dirty="0"/>
          </a:p>
        </p:txBody>
      </p:sp>
      <p:sp>
        <p:nvSpPr>
          <p:cNvPr id="54" name="TextBox 53"/>
          <p:cNvSpPr txBox="1"/>
          <p:nvPr/>
        </p:nvSpPr>
        <p:spPr>
          <a:xfrm>
            <a:off x="5674215" y="9257578"/>
            <a:ext cx="378877" cy="107722"/>
          </a:xfrm>
          <a:prstGeom prst="rect">
            <a:avLst/>
          </a:prstGeom>
          <a:solidFill>
            <a:schemeClr val="bg1"/>
          </a:solidFill>
        </p:spPr>
        <p:txBody>
          <a:bodyPr wrap="none" lIns="36000" tIns="0" rIns="36000" bIns="0" rtlCol="0">
            <a:spAutoFit/>
          </a:bodyPr>
          <a:lstStyle/>
          <a:p>
            <a:r>
              <a:rPr lang="en-GB" sz="700" b="1" dirty="0" smtClean="0"/>
              <a:t>Cycle 48</a:t>
            </a:r>
            <a:endParaRPr lang="en-US" sz="700" b="1" dirty="0"/>
          </a:p>
        </p:txBody>
      </p:sp>
    </p:spTree>
    <p:extLst>
      <p:ext uri="{BB962C8B-B14F-4D97-AF65-F5344CB8AC3E}">
        <p14:creationId xmlns:p14="http://schemas.microsoft.com/office/powerpoint/2010/main" val="4145394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87</Words>
  <Application>Microsoft Office PowerPoint</Application>
  <PresentationFormat>A4 Paper (210x297 mm)</PresentationFormat>
  <Paragraphs>4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adelph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il A</dc:creator>
  <cp:lastModifiedBy>Neil A</cp:lastModifiedBy>
  <cp:revision>3</cp:revision>
  <dcterms:created xsi:type="dcterms:W3CDTF">2015-08-12T12:57:25Z</dcterms:created>
  <dcterms:modified xsi:type="dcterms:W3CDTF">2015-08-12T13:23:56Z</dcterms:modified>
</cp:coreProperties>
</file>